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6.xml.rels" ContentType="application/vnd.openxmlformats-package.relationships+xml"/>
  <Override PartName="/ppt/notesSlides/notesSlide6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10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144000" cy="6858000"/>
  <p:notesSz cx="6900863" cy="92916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901200" cy="929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9088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08520" y="0"/>
            <a:ext cx="299088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26800" y="696600"/>
            <a:ext cx="4646520" cy="3484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90120" y="4414320"/>
            <a:ext cx="5519880" cy="417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25040"/>
            <a:ext cx="299088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08520" y="8825040"/>
            <a:ext cx="2990880" cy="46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4C7956-D0BD-467F-9BBD-4A070EB1E26C}" type="slidenum">
              <a:rPr b="1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sldImg"/>
          </p:nvPr>
        </p:nvSpPr>
        <p:spPr>
          <a:xfrm>
            <a:off x="1127160" y="696960"/>
            <a:ext cx="4646520" cy="3484440"/>
          </a:xfrm>
          <a:prstGeom prst="rect">
            <a:avLst/>
          </a:prstGeom>
          <a:ln w="0">
            <a:noFill/>
          </a:ln>
        </p:spPr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690120" y="4414320"/>
            <a:ext cx="5519880" cy="417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  <a:ea typeface="宋体"/>
            </a:endParaRPr>
          </a:p>
        </p:txBody>
      </p:sp>
      <p:sp>
        <p:nvSpPr>
          <p:cNvPr id="73" name="Slide Number Placeholder 3"/>
          <p:cNvSpPr/>
          <p:nvPr/>
        </p:nvSpPr>
        <p:spPr>
          <a:xfrm>
            <a:off x="3908520" y="8825040"/>
            <a:ext cx="299088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FF68ED-135B-4475-AFEC-A73B8F554CB8}" type="slidenum">
              <a:rPr b="1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C16F5A-290E-4F5B-8AAA-4A9DF95D15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706AD-8739-4F90-9211-FCA6537563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52145C-FE3B-41B9-B4D8-2C41AADA27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6ECFD-2FCE-42D1-9451-8974A894CF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55A93-4D5A-4D15-A17A-415E017C80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14988-4B8F-4B86-AF30-BA785CB2A6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B6127A-D2B3-407E-974A-E0D07BC4AE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13C37-3F03-45BE-A81A-7EAF7AF33C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08088B-A392-4A7E-AF60-04964FBFF1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17362C-6FBC-416F-A5E2-382DE43C36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822F0-52BA-400B-9255-15291F549C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51D58B-1ED0-4405-A819-B2D5458048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B4EA70-C0CE-40BF-8881-89BDBAE5CA50}" type="slidenum">
              <a:rPr b="1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148" descr=""/>
          <p:cNvPicPr/>
          <p:nvPr/>
        </p:nvPicPr>
        <p:blipFill>
          <a:blip r:embed="rId1"/>
          <a:srcRect l="7267" t="40621" r="46885" b="45310"/>
          <a:stretch/>
        </p:blipFill>
        <p:spPr>
          <a:xfrm>
            <a:off x="2084400" y="1190520"/>
            <a:ext cx="4708440" cy="2459160"/>
          </a:xfrm>
          <a:prstGeom prst="rect">
            <a:avLst/>
          </a:prstGeom>
          <a:ln w="0">
            <a:noFill/>
          </a:ln>
        </p:spPr>
      </p:pic>
      <p:sp>
        <p:nvSpPr>
          <p:cNvPr id="49" name="TextBox 83"/>
          <p:cNvSpPr/>
          <p:nvPr/>
        </p:nvSpPr>
        <p:spPr>
          <a:xfrm>
            <a:off x="207000" y="304920"/>
            <a:ext cx="235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1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8" descr="SW480.jpg"/>
          <p:cNvPicPr/>
          <p:nvPr/>
        </p:nvPicPr>
        <p:blipFill>
          <a:blip r:embed="rId1"/>
          <a:srcRect l="0" t="61009" r="0" b="6578"/>
          <a:stretch/>
        </p:blipFill>
        <p:spPr>
          <a:xfrm>
            <a:off x="2192400" y="1563840"/>
            <a:ext cx="4657680" cy="3214440"/>
          </a:xfrm>
          <a:prstGeom prst="rect">
            <a:avLst/>
          </a:prstGeom>
          <a:ln w="0">
            <a:noFill/>
          </a:ln>
        </p:spPr>
      </p:pic>
      <p:sp>
        <p:nvSpPr>
          <p:cNvPr id="51" name="Text Box 39"/>
          <p:cNvSpPr/>
          <p:nvPr/>
        </p:nvSpPr>
        <p:spPr>
          <a:xfrm>
            <a:off x="3871800" y="4770360"/>
            <a:ext cx="129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1000 cells/ well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8"/>
          <p:cNvSpPr/>
          <p:nvPr/>
        </p:nvSpPr>
        <p:spPr>
          <a:xfrm>
            <a:off x="633240" y="1830240"/>
            <a:ext cx="15242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LD-1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LDH+/CD133+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8"/>
          <p:cNvSpPr/>
          <p:nvPr/>
        </p:nvSpPr>
        <p:spPr>
          <a:xfrm>
            <a:off x="657360" y="3470400"/>
            <a:ext cx="15238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LD-1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LDH- /CD133-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83"/>
          <p:cNvSpPr/>
          <p:nvPr/>
        </p:nvSpPr>
        <p:spPr>
          <a:xfrm>
            <a:off x="207000" y="304920"/>
            <a:ext cx="235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2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8" descr="rt.png"/>
          <p:cNvPicPr/>
          <p:nvPr/>
        </p:nvPicPr>
        <p:blipFill>
          <a:blip r:embed="rId1"/>
          <a:stretch/>
        </p:blipFill>
        <p:spPr>
          <a:xfrm>
            <a:off x="709560" y="1468440"/>
            <a:ext cx="7947000" cy="2695680"/>
          </a:xfrm>
          <a:prstGeom prst="rect">
            <a:avLst/>
          </a:prstGeom>
          <a:ln w="0">
            <a:noFill/>
          </a:ln>
        </p:spPr>
      </p:pic>
      <p:sp>
        <p:nvSpPr>
          <p:cNvPr id="56" name="TextBox 83"/>
          <p:cNvSpPr/>
          <p:nvPr/>
        </p:nvSpPr>
        <p:spPr>
          <a:xfrm>
            <a:off x="207000" y="304920"/>
            <a:ext cx="235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3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3" descr="s figure3.png"/>
          <p:cNvPicPr/>
          <p:nvPr/>
        </p:nvPicPr>
        <p:blipFill>
          <a:blip r:embed="rId1"/>
          <a:stretch/>
        </p:blipFill>
        <p:spPr>
          <a:xfrm>
            <a:off x="1436760" y="1332000"/>
            <a:ext cx="6210360" cy="3168720"/>
          </a:xfrm>
          <a:prstGeom prst="rect">
            <a:avLst/>
          </a:prstGeom>
          <a:ln w="0">
            <a:noFill/>
          </a:ln>
        </p:spPr>
      </p:pic>
      <p:sp>
        <p:nvSpPr>
          <p:cNvPr id="58" name="TextBox 83"/>
          <p:cNvSpPr/>
          <p:nvPr/>
        </p:nvSpPr>
        <p:spPr>
          <a:xfrm>
            <a:off x="207000" y="304920"/>
            <a:ext cx="235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4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93" descr="S FIGURE 2A"/>
          <p:cNvPicPr/>
          <p:nvPr/>
        </p:nvPicPr>
        <p:blipFill>
          <a:blip r:embed="rId1"/>
          <a:stretch/>
        </p:blipFill>
        <p:spPr>
          <a:xfrm>
            <a:off x="295200" y="1046160"/>
            <a:ext cx="4151520" cy="392760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94" descr="S FIGURE 2B"/>
          <p:cNvPicPr/>
          <p:nvPr/>
        </p:nvPicPr>
        <p:blipFill>
          <a:blip r:embed="rId2"/>
          <a:stretch/>
        </p:blipFill>
        <p:spPr>
          <a:xfrm>
            <a:off x="4822920" y="1023840"/>
            <a:ext cx="3763800" cy="241776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96" descr="S FIGURE 2C"/>
          <p:cNvPicPr/>
          <p:nvPr/>
        </p:nvPicPr>
        <p:blipFill>
          <a:blip r:embed="rId3"/>
          <a:stretch/>
        </p:blipFill>
        <p:spPr>
          <a:xfrm>
            <a:off x="4888080" y="4013280"/>
            <a:ext cx="3876480" cy="2038320"/>
          </a:xfrm>
          <a:prstGeom prst="rect">
            <a:avLst/>
          </a:prstGeom>
          <a:ln w="0">
            <a:noFill/>
          </a:ln>
        </p:spPr>
      </p:pic>
      <p:sp>
        <p:nvSpPr>
          <p:cNvPr id="62" name="TextBox 83"/>
          <p:cNvSpPr/>
          <p:nvPr/>
        </p:nvSpPr>
        <p:spPr>
          <a:xfrm>
            <a:off x="207000" y="304920"/>
            <a:ext cx="235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5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9" descr="HCT116-ALDH,CD133.png"/>
          <p:cNvPicPr/>
          <p:nvPr/>
        </p:nvPicPr>
        <p:blipFill>
          <a:blip r:embed="rId1"/>
          <a:stretch/>
        </p:blipFill>
        <p:spPr>
          <a:xfrm>
            <a:off x="755640" y="1420920"/>
            <a:ext cx="3011400" cy="273024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10" descr="SW480-ALDH,CD133.png"/>
          <p:cNvPicPr/>
          <p:nvPr/>
        </p:nvPicPr>
        <p:blipFill>
          <a:blip r:embed="rId2"/>
          <a:stretch/>
        </p:blipFill>
        <p:spPr>
          <a:xfrm>
            <a:off x="4167360" y="1409760"/>
            <a:ext cx="3101760" cy="2730600"/>
          </a:xfrm>
          <a:prstGeom prst="rect">
            <a:avLst/>
          </a:prstGeom>
          <a:ln w="0">
            <a:noFill/>
          </a:ln>
        </p:spPr>
      </p:pic>
      <p:sp>
        <p:nvSpPr>
          <p:cNvPr id="65" name="TextBox 83"/>
          <p:cNvSpPr/>
          <p:nvPr/>
        </p:nvSpPr>
        <p:spPr>
          <a:xfrm>
            <a:off x="207000" y="304920"/>
            <a:ext cx="235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Supplemental Figure 6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Rectangle 3"/>
          <p:cNvSpPr/>
          <p:nvPr/>
        </p:nvSpPr>
        <p:spPr>
          <a:xfrm>
            <a:off x="1276920" y="0"/>
            <a:ext cx="22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Supplemental Table 1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4" descr="S TABLE 1.png"/>
          <p:cNvPicPr/>
          <p:nvPr/>
        </p:nvPicPr>
        <p:blipFill>
          <a:blip r:embed="rId1"/>
          <a:stretch/>
        </p:blipFill>
        <p:spPr>
          <a:xfrm>
            <a:off x="1285920" y="347760"/>
            <a:ext cx="6572160" cy="6510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8" name=""/>
          <p:cNvGraphicFramePr/>
          <p:nvPr/>
        </p:nvGraphicFramePr>
        <p:xfrm>
          <a:off x="1487520" y="1859040"/>
          <a:ext cx="4843440" cy="1676160"/>
        </p:xfrm>
        <a:graphic>
          <a:graphicData uri="http://schemas.openxmlformats.org/drawingml/2006/table">
            <a:tbl>
              <a:tblPr/>
              <a:tblGrid>
                <a:gridCol w="1163520"/>
                <a:gridCol w="1598760"/>
                <a:gridCol w="2081160"/>
              </a:tblGrid>
              <a:tr h="337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lon cancer cell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lon cancer Stem cell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LD-1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0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10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CT116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61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W480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1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62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7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T29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6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60</a:t>
                      </a:r>
                      <a:endParaRPr b="1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9" name="Rectangle 3"/>
          <p:cNvSpPr/>
          <p:nvPr/>
        </p:nvSpPr>
        <p:spPr>
          <a:xfrm>
            <a:off x="482400" y="622440"/>
            <a:ext cx="226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Supplemental Table 2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3"/>
          <p:cNvSpPr/>
          <p:nvPr/>
        </p:nvSpPr>
        <p:spPr>
          <a:xfrm>
            <a:off x="1095480" y="3637080"/>
            <a:ext cx="5667120" cy="121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half-maximal inhibitory concentrations (IC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5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µM) obtained for GO-Y030 in colon cancer cells and  colon cancer stem cells. Cells were incubated with GO-Y030 in triplicate at 37˚C for 72 hours.  3-(4,5-Dimethylthiazolyl)-2,5-diphenyltetrazolium bromide (MTT) viability assay was performed and the absorbance was recorded at 595 nm.  IC50 values were determined using Sigma Plot 9.0 Software (Systat Software Inc., San Jose, CA)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05T14:45:51Z</dcterms:created>
  <dc:creator>Administrator</dc:creator>
  <dc:description/>
  <dc:language>en-US</dc:language>
  <cp:lastModifiedBy>linj</cp:lastModifiedBy>
  <dcterms:modified xsi:type="dcterms:W3CDTF">2011-04-29T17:43:34Z</dcterms:modified>
  <cp:revision>421</cp:revision>
  <dc:subject/>
  <dc:title>Slide 1</dc:title>
</cp:coreProperties>
</file>